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1" autoAdjust="0"/>
    <p:restoredTop sz="94660"/>
  </p:normalViewPr>
  <p:slideViewPr>
    <p:cSldViewPr snapToGrid="0">
      <p:cViewPr varScale="1">
        <p:scale>
          <a:sx n="45" d="100"/>
          <a:sy n="45" d="100"/>
        </p:scale>
        <p:origin x="24" y="9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D8321-1547-43F4-8941-D060DE2BDDC0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6B497-B776-4AF5-A90A-0BF867953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9147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D8321-1547-43F4-8941-D060DE2BDDC0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6B497-B776-4AF5-A90A-0BF867953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226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D8321-1547-43F4-8941-D060DE2BDDC0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6B497-B776-4AF5-A90A-0BF867953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4183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D8321-1547-43F4-8941-D060DE2BDDC0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6B497-B776-4AF5-A90A-0BF867953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13035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D8321-1547-43F4-8941-D060DE2BDDC0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6B497-B776-4AF5-A90A-0BF867953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70300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D8321-1547-43F4-8941-D060DE2BDDC0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6B497-B776-4AF5-A90A-0BF867953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78333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D8321-1547-43F4-8941-D060DE2BDDC0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6B497-B776-4AF5-A90A-0BF867953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40607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D8321-1547-43F4-8941-D060DE2BDDC0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6B497-B776-4AF5-A90A-0BF867953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94179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D8321-1547-43F4-8941-D060DE2BDDC0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6B497-B776-4AF5-A90A-0BF867953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82428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D8321-1547-43F4-8941-D060DE2BDDC0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6B497-B776-4AF5-A90A-0BF867953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00054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D8321-1547-43F4-8941-D060DE2BDDC0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C6B497-B776-4AF5-A90A-0BF867953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5034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DD8321-1547-43F4-8941-D060DE2BDDC0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C6B497-B776-4AF5-A90A-0BF867953E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7210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6696" y="577517"/>
            <a:ext cx="9804349" cy="5170186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1540933" y="5747703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vi-VN" altLang="en-US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igure </a:t>
            </a: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S28</a:t>
            </a:r>
            <a:r>
              <a:rPr kumimoji="0" lang="vi-VN" altLang="en-US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. 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Correlation between β-</a:t>
            </a:r>
            <a:r>
              <a:rPr kumimoji="0" lang="vi-VN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atin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inhibition activity 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(BIHA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, µM)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nd </a:t>
            </a:r>
            <a:r>
              <a:rPr kumimoji="0" lang="vi-VN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­, µM)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for acridines against 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sensitive strain 3D7</a:t>
            </a: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99507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6:18:08Z</dcterms:created>
  <dcterms:modified xsi:type="dcterms:W3CDTF">2020-08-04T16:37:24Z</dcterms:modified>
</cp:coreProperties>
</file>